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33E332-16E2-40C6-8A5D-7D5F7403EAA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B31E1E-586A-4327-ADD9-9B2AAB0E06A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C7A883-6DF6-46B0-B5FF-204BC8033CB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8C8186-496C-43FA-9410-EB7751D9324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564540-F947-4121-9B97-4F1CCD8F754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D9EC50-E0B9-4A21-A2FA-F711AC548EE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B29EF5-5DD8-4F2A-A720-2E0BB2DBCDF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632062-1D29-4885-A443-33067E8E29F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EBBC47-421B-430A-986E-32838691965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732320-4D21-4E5B-A36C-FEE5B5F6A32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102D0E-F9A4-4A3A-B5CA-1F7221BFF55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B894A6-CDF9-4BAE-8934-4D5C3D4C97E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BC0918B-C79A-4D2F-A91D-56275861A05F}" type="slidenum">
              <a:rPr b="0" lang="fr-F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image" Target="../media/image1.png"/><Relationship Id="rId5" Type="http://schemas.openxmlformats.org/officeDocument/2006/relationships/image" Target="../media/image1.png"/><Relationship Id="rId6" Type="http://schemas.openxmlformats.org/officeDocument/2006/relationships/image" Target="../media/image2.png"/><Relationship Id="rId7" Type="http://schemas.openxmlformats.org/officeDocument/2006/relationships/image" Target="../media/image3.png"/><Relationship Id="rId8" Type="http://schemas.openxmlformats.org/officeDocument/2006/relationships/image" Target="../media/image4.png"/><Relationship Id="rId9" Type="http://schemas.openxmlformats.org/officeDocument/2006/relationships/image" Target="../media/image3.png"/><Relationship Id="rId10" Type="http://schemas.openxmlformats.org/officeDocument/2006/relationships/image" Target="../media/image4.png"/><Relationship Id="rId11" Type="http://schemas.openxmlformats.org/officeDocument/2006/relationships/image" Target="../media/image5.png"/><Relationship Id="rId12" Type="http://schemas.openxmlformats.org/officeDocument/2006/relationships/image" Target="../media/image5.png"/><Relationship Id="rId13" Type="http://schemas.openxmlformats.org/officeDocument/2006/relationships/image" Target="../media/image5.png"/><Relationship Id="rId14" Type="http://schemas.openxmlformats.org/officeDocument/2006/relationships/image" Target="../media/image5.png"/><Relationship Id="rId15" Type="http://schemas.openxmlformats.org/officeDocument/2006/relationships/image" Target="../media/image5.png"/><Relationship Id="rId16" Type="http://schemas.openxmlformats.org/officeDocument/2006/relationships/image" Target="../media/image5.png"/><Relationship Id="rId1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AutoShape 4"/>
          <p:cNvSpPr/>
          <p:nvPr/>
        </p:nvSpPr>
        <p:spPr>
          <a:xfrm>
            <a:off x="5865840" y="4471920"/>
            <a:ext cx="42840" cy="1062000"/>
          </a:xfrm>
          <a:custGeom>
            <a:avLst/>
            <a:gdLst>
              <a:gd name="textAreaLeft" fmla="*/ 6120 w 42840"/>
              <a:gd name="textAreaRight" fmla="*/ 36720 w 42840"/>
              <a:gd name="textAreaTop" fmla="*/ 6120 h 1062000"/>
              <a:gd name="textAreaBottom" fmla="*/ 1055880 h 1062000"/>
            </a:gdLst>
            <a:ahLst/>
            <a:rect l="textAreaLeft" t="textAreaTop" r="textAreaRight" b="textAreaBottom"/>
            <a:pathLst>
              <a:path w="21600" h="531180">
                <a:moveTo>
                  <a:pt x="10800" y="0"/>
                </a:moveTo>
                <a:arcTo wR="10800" hR="10800" stAng="16200000" swAng="-5400000"/>
                <a:lnTo>
                  <a:pt x="0" y="520380"/>
                </a:lnTo>
                <a:arcTo wR="10800" hR="10800" stAng="10800000" swAng="-5400000"/>
                <a:lnTo>
                  <a:pt x="10800" y="531180"/>
                </a:lnTo>
                <a:arcTo wR="10800" hR="10800" stAng="5400000" swAng="-5400000"/>
                <a:lnTo>
                  <a:pt x="21600" y="10800"/>
                </a:lnTo>
                <a:arcTo wR="10800" hR="10800" stAng="0" swAng="-5400000"/>
                <a:close/>
              </a:path>
            </a:pathLst>
          </a:custGeom>
          <a:noFill/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5"/>
          <p:cNvSpPr/>
          <p:nvPr/>
        </p:nvSpPr>
        <p:spPr>
          <a:xfrm>
            <a:off x="5815800" y="4343400"/>
            <a:ext cx="128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1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AutoShape 6"/>
          <p:cNvSpPr/>
          <p:nvPr/>
        </p:nvSpPr>
        <p:spPr>
          <a:xfrm>
            <a:off x="7089840" y="4471920"/>
            <a:ext cx="47520" cy="1868400"/>
          </a:xfrm>
          <a:custGeom>
            <a:avLst/>
            <a:gdLst>
              <a:gd name="textAreaLeft" fmla="*/ 6840 w 47520"/>
              <a:gd name="textAreaRight" fmla="*/ 40680 w 47520"/>
              <a:gd name="textAreaTop" fmla="*/ 6840 h 1868400"/>
              <a:gd name="textAreaBottom" fmla="*/ 1861560 h 1868400"/>
            </a:gdLst>
            <a:ahLst/>
            <a:rect l="textAreaLeft" t="textAreaTop" r="textAreaRight" b="textAreaBottom"/>
            <a:pathLst>
              <a:path w="21600" h="843050">
                <a:moveTo>
                  <a:pt x="10800" y="0"/>
                </a:moveTo>
                <a:arcTo wR="10800" hR="10800" stAng="16200000" swAng="-5400000"/>
                <a:lnTo>
                  <a:pt x="0" y="832250"/>
                </a:lnTo>
                <a:arcTo wR="10800" hR="10800" stAng="10800000" swAng="-5400000"/>
                <a:lnTo>
                  <a:pt x="10800" y="843050"/>
                </a:lnTo>
                <a:arcTo wR="10800" hR="10800" stAng="5400000" swAng="-5400000"/>
                <a:lnTo>
                  <a:pt x="21600" y="10800"/>
                </a:lnTo>
                <a:arcTo wR="10800" hR="10800" stAng="0" swAng="-5400000"/>
                <a:close/>
              </a:path>
            </a:pathLst>
          </a:custGeom>
          <a:noFill/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7"/>
          <p:cNvSpPr/>
          <p:nvPr/>
        </p:nvSpPr>
        <p:spPr>
          <a:xfrm>
            <a:off x="7035120" y="4343400"/>
            <a:ext cx="128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1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AutoShape 8"/>
          <p:cNvSpPr/>
          <p:nvPr/>
        </p:nvSpPr>
        <p:spPr>
          <a:xfrm>
            <a:off x="3811680" y="4471920"/>
            <a:ext cx="50760" cy="2175120"/>
          </a:xfrm>
          <a:custGeom>
            <a:avLst/>
            <a:gdLst>
              <a:gd name="textAreaLeft" fmla="*/ 6120 w 50760"/>
              <a:gd name="textAreaRight" fmla="*/ 44640 w 50760"/>
              <a:gd name="textAreaTop" fmla="*/ 6120 h 2175120"/>
              <a:gd name="textAreaBottom" fmla="*/ 2169000 h 2175120"/>
            </a:gdLst>
            <a:ahLst/>
            <a:rect l="textAreaLeft" t="textAreaTop" r="textAreaRight" b="textAreaBottom"/>
            <a:pathLst>
              <a:path w="21600" h="919217">
                <a:moveTo>
                  <a:pt x="9138" y="0"/>
                </a:moveTo>
                <a:arcTo wR="9138" hR="9138" stAng="16200000" swAng="-5400000"/>
                <a:lnTo>
                  <a:pt x="0" y="910079"/>
                </a:lnTo>
                <a:arcTo wR="9138" hR="9138" stAng="10800000" swAng="-5400000"/>
                <a:lnTo>
                  <a:pt x="12462" y="919217"/>
                </a:lnTo>
                <a:arcTo wR="9138" hR="9138" stAng="5400000" swAng="-5400000"/>
                <a:lnTo>
                  <a:pt x="21600" y="9138"/>
                </a:lnTo>
                <a:arcTo wR="9138" hR="9138" stAng="0" swAng="-5400000"/>
                <a:close/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AutoShape 9"/>
          <p:cNvSpPr/>
          <p:nvPr/>
        </p:nvSpPr>
        <p:spPr>
          <a:xfrm>
            <a:off x="5029200" y="4471920"/>
            <a:ext cx="52560" cy="506520"/>
          </a:xfrm>
          <a:custGeom>
            <a:avLst/>
            <a:gdLst>
              <a:gd name="textAreaLeft" fmla="*/ 7560 w 52560"/>
              <a:gd name="textAreaRight" fmla="*/ 45000 w 52560"/>
              <a:gd name="textAreaTop" fmla="*/ 7560 h 506520"/>
              <a:gd name="textAreaBottom" fmla="*/ 498960 h 506520"/>
            </a:gdLst>
            <a:ahLst/>
            <a:rect l="textAreaLeft" t="textAreaTop" r="textAreaRight" b="textAreaBottom"/>
            <a:pathLst>
              <a:path w="21600" h="206890">
                <a:moveTo>
                  <a:pt x="10800" y="0"/>
                </a:moveTo>
                <a:arcTo wR="10800" hR="10800" stAng="16200000" swAng="-5400000"/>
                <a:lnTo>
                  <a:pt x="0" y="196090"/>
                </a:lnTo>
                <a:arcTo wR="10800" hR="10800" stAng="10800000" swAng="-5400000"/>
                <a:lnTo>
                  <a:pt x="10800" y="206890"/>
                </a:lnTo>
                <a:arcTo wR="10800" hR="10800" stAng="5400000" swAng="-5400000"/>
                <a:lnTo>
                  <a:pt x="21600" y="10800"/>
                </a:lnTo>
                <a:arcTo wR="10800" hR="10800" stAng="0" swAng="-5400000"/>
                <a:close/>
              </a:path>
            </a:pathLst>
          </a:custGeom>
          <a:noFill/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tangle 10"/>
          <p:cNvSpPr/>
          <p:nvPr/>
        </p:nvSpPr>
        <p:spPr>
          <a:xfrm>
            <a:off x="4977720" y="4343400"/>
            <a:ext cx="128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AutoShape 11"/>
          <p:cNvSpPr/>
          <p:nvPr/>
        </p:nvSpPr>
        <p:spPr>
          <a:xfrm>
            <a:off x="5049720" y="5486400"/>
            <a:ext cx="55800" cy="870120"/>
          </a:xfrm>
          <a:custGeom>
            <a:avLst/>
            <a:gdLst>
              <a:gd name="textAreaLeft" fmla="*/ 7920 w 55800"/>
              <a:gd name="textAreaRight" fmla="*/ 47880 w 55800"/>
              <a:gd name="textAreaTop" fmla="*/ 7920 h 870120"/>
              <a:gd name="textAreaBottom" fmla="*/ 862200 h 870120"/>
            </a:gdLst>
            <a:ahLst/>
            <a:rect l="textAreaLeft" t="textAreaTop" r="textAreaRight" b="textAreaBottom"/>
            <a:pathLst>
              <a:path w="21600" h="334800">
                <a:moveTo>
                  <a:pt x="10800" y="0"/>
                </a:moveTo>
                <a:arcTo wR="10800" hR="10800" stAng="16200000" swAng="-5400000"/>
                <a:lnTo>
                  <a:pt x="0" y="324000"/>
                </a:lnTo>
                <a:arcTo wR="10800" hR="10800" stAng="10800000" swAng="-5400000"/>
                <a:lnTo>
                  <a:pt x="10800" y="334800"/>
                </a:lnTo>
                <a:arcTo wR="10800" hR="10800" stAng="5400000" swAng="-5400000"/>
                <a:lnTo>
                  <a:pt x="21600" y="10800"/>
                </a:lnTo>
                <a:arcTo wR="10800" hR="10800" stAng="0" swAng="-5400000"/>
                <a:close/>
              </a:path>
            </a:pathLst>
          </a:cu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12"/>
          <p:cNvSpPr/>
          <p:nvPr/>
        </p:nvSpPr>
        <p:spPr>
          <a:xfrm>
            <a:off x="4977720" y="5348160"/>
            <a:ext cx="128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1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AutoShape 13"/>
          <p:cNvSpPr/>
          <p:nvPr/>
        </p:nvSpPr>
        <p:spPr>
          <a:xfrm>
            <a:off x="8209080" y="4471920"/>
            <a:ext cx="46080" cy="1438200"/>
          </a:xfrm>
          <a:custGeom>
            <a:avLst/>
            <a:gdLst>
              <a:gd name="textAreaLeft" fmla="*/ 6480 w 46080"/>
              <a:gd name="textAreaRight" fmla="*/ 39600 w 46080"/>
              <a:gd name="textAreaTop" fmla="*/ 6480 h 1438200"/>
              <a:gd name="textAreaBottom" fmla="*/ 1431720 h 1438200"/>
            </a:gdLst>
            <a:ahLst/>
            <a:rect l="textAreaLeft" t="textAreaTop" r="textAreaRight" b="textAreaBottom"/>
            <a:pathLst>
              <a:path w="21600" h="669098">
                <a:moveTo>
                  <a:pt x="10800" y="0"/>
                </a:moveTo>
                <a:arcTo wR="10800" hR="10800" stAng="16200000" swAng="-5400000"/>
                <a:lnTo>
                  <a:pt x="0" y="658298"/>
                </a:lnTo>
                <a:arcTo wR="10800" hR="10800" stAng="10800000" swAng="-5400000"/>
                <a:lnTo>
                  <a:pt x="10800" y="669098"/>
                </a:lnTo>
                <a:arcTo wR="10800" hR="10800" stAng="5400000" swAng="-5400000"/>
                <a:lnTo>
                  <a:pt x="21600" y="10800"/>
                </a:lnTo>
                <a:arcTo wR="10800" hR="10800" stAng="0" swAng="-5400000"/>
                <a:close/>
              </a:path>
            </a:pathLst>
          </a:cu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14"/>
          <p:cNvSpPr/>
          <p:nvPr/>
        </p:nvSpPr>
        <p:spPr>
          <a:xfrm>
            <a:off x="8154360" y="4343400"/>
            <a:ext cx="128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19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AutoShape 15"/>
          <p:cNvSpPr/>
          <p:nvPr/>
        </p:nvSpPr>
        <p:spPr>
          <a:xfrm>
            <a:off x="592200" y="4471920"/>
            <a:ext cx="52200" cy="1530360"/>
          </a:xfrm>
          <a:custGeom>
            <a:avLst/>
            <a:gdLst>
              <a:gd name="textAreaLeft" fmla="*/ 7560 w 52200"/>
              <a:gd name="textAreaRight" fmla="*/ 44640 w 52200"/>
              <a:gd name="textAreaTop" fmla="*/ 7560 h 1530360"/>
              <a:gd name="textAreaBottom" fmla="*/ 1522800 h 1530360"/>
            </a:gdLst>
            <a:ahLst/>
            <a:rect l="textAreaLeft" t="textAreaTop" r="textAreaRight" b="textAreaBottom"/>
            <a:pathLst>
              <a:path w="21600" h="629063">
                <a:moveTo>
                  <a:pt x="10800" y="0"/>
                </a:moveTo>
                <a:arcTo wR="10800" hR="10800" stAng="16200000" swAng="-5400000"/>
                <a:lnTo>
                  <a:pt x="0" y="618263"/>
                </a:lnTo>
                <a:arcTo wR="10800" hR="10800" stAng="10800000" swAng="-5400000"/>
                <a:lnTo>
                  <a:pt x="10800" y="629063"/>
                </a:lnTo>
                <a:arcTo wR="10800" hR="10800" stAng="5400000" swAng="-5400000"/>
                <a:lnTo>
                  <a:pt x="21600" y="10800"/>
                </a:lnTo>
                <a:arcTo wR="10800" hR="10800" stAng="0" swAng="-5400000"/>
                <a:close/>
              </a:path>
            </a:pathLst>
          </a:custGeom>
          <a:noFill/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16"/>
          <p:cNvSpPr/>
          <p:nvPr/>
        </p:nvSpPr>
        <p:spPr>
          <a:xfrm>
            <a:off x="558000" y="4343400"/>
            <a:ext cx="128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1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AutoShape 17"/>
          <p:cNvSpPr/>
          <p:nvPr/>
        </p:nvSpPr>
        <p:spPr>
          <a:xfrm>
            <a:off x="1746360" y="4471920"/>
            <a:ext cx="52200" cy="1049400"/>
          </a:xfrm>
          <a:custGeom>
            <a:avLst/>
            <a:gdLst>
              <a:gd name="textAreaLeft" fmla="*/ 7560 w 52200"/>
              <a:gd name="textAreaRight" fmla="*/ 44640 w 52200"/>
              <a:gd name="textAreaTop" fmla="*/ 7560 h 1049400"/>
              <a:gd name="textAreaBottom" fmla="*/ 1041840 h 1049400"/>
            </a:gdLst>
            <a:ahLst/>
            <a:rect l="textAreaLeft" t="textAreaTop" r="textAreaRight" b="textAreaBottom"/>
            <a:pathLst>
              <a:path w="21600" h="431408">
                <a:moveTo>
                  <a:pt x="10800" y="0"/>
                </a:moveTo>
                <a:arcTo wR="10800" hR="10800" stAng="16200000" swAng="-5400000"/>
                <a:lnTo>
                  <a:pt x="0" y="420608"/>
                </a:lnTo>
                <a:arcTo wR="10800" hR="10800" stAng="10800000" swAng="-5400000"/>
                <a:lnTo>
                  <a:pt x="10800" y="431408"/>
                </a:lnTo>
                <a:arcTo wR="10800" hR="10800" stAng="5400000" swAng="-5400000"/>
                <a:lnTo>
                  <a:pt x="21600" y="10800"/>
                </a:lnTo>
                <a:arcTo wR="10800" hR="10800" stAng="0" swAng="-5400000"/>
                <a:close/>
              </a:path>
            </a:pathLst>
          </a:custGeom>
          <a:noFill/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18"/>
          <p:cNvSpPr/>
          <p:nvPr/>
        </p:nvSpPr>
        <p:spPr>
          <a:xfrm>
            <a:off x="1701000" y="4343400"/>
            <a:ext cx="128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1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AutoShape 19"/>
          <p:cNvSpPr/>
          <p:nvPr/>
        </p:nvSpPr>
        <p:spPr>
          <a:xfrm>
            <a:off x="2927520" y="4471920"/>
            <a:ext cx="52200" cy="1567080"/>
          </a:xfrm>
          <a:custGeom>
            <a:avLst/>
            <a:gdLst>
              <a:gd name="textAreaLeft" fmla="*/ 7560 w 52200"/>
              <a:gd name="textAreaRight" fmla="*/ 44640 w 52200"/>
              <a:gd name="textAreaTop" fmla="*/ 7560 h 1567080"/>
              <a:gd name="textAreaBottom" fmla="*/ 1559520 h 1567080"/>
            </a:gdLst>
            <a:ahLst/>
            <a:rect l="textAreaLeft" t="textAreaTop" r="textAreaRight" b="textAreaBottom"/>
            <a:pathLst>
              <a:path w="21600" h="644153">
                <a:moveTo>
                  <a:pt x="10800" y="0"/>
                </a:moveTo>
                <a:arcTo wR="10800" hR="10800" stAng="16200000" swAng="-5400000"/>
                <a:lnTo>
                  <a:pt x="0" y="633353"/>
                </a:lnTo>
                <a:arcTo wR="10800" hR="10800" stAng="10800000" swAng="-5400000"/>
                <a:lnTo>
                  <a:pt x="10800" y="644153"/>
                </a:lnTo>
                <a:arcTo wR="10800" hR="10800" stAng="5400000" swAng="-5400000"/>
                <a:lnTo>
                  <a:pt x="21600" y="10800"/>
                </a:lnTo>
                <a:arcTo wR="10800" hR="10800" stAng="0" swAng="-5400000"/>
                <a:close/>
              </a:path>
            </a:pathLst>
          </a:custGeom>
          <a:noFill/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20"/>
          <p:cNvSpPr/>
          <p:nvPr/>
        </p:nvSpPr>
        <p:spPr>
          <a:xfrm>
            <a:off x="2880360" y="4343400"/>
            <a:ext cx="128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1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AutoShape 21"/>
          <p:cNvSpPr/>
          <p:nvPr/>
        </p:nvSpPr>
        <p:spPr>
          <a:xfrm>
            <a:off x="571680" y="1573200"/>
            <a:ext cx="55440" cy="1935000"/>
          </a:xfrm>
          <a:custGeom>
            <a:avLst/>
            <a:gdLst>
              <a:gd name="textAreaLeft" fmla="*/ 7920 w 55440"/>
              <a:gd name="textAreaRight" fmla="*/ 47520 w 55440"/>
              <a:gd name="textAreaTop" fmla="*/ 7920 h 1935000"/>
              <a:gd name="textAreaBottom" fmla="*/ 1927080 h 1935000"/>
            </a:gdLst>
            <a:ahLst/>
            <a:rect l="textAreaLeft" t="textAreaTop" r="textAreaRight" b="textAreaBottom"/>
            <a:pathLst>
              <a:path w="21600" h="749172">
                <a:moveTo>
                  <a:pt x="10800" y="0"/>
                </a:moveTo>
                <a:arcTo wR="10800" hR="10800" stAng="16200000" swAng="-5400000"/>
                <a:lnTo>
                  <a:pt x="0" y="738372"/>
                </a:lnTo>
                <a:arcTo wR="10800" hR="10800" stAng="10800000" swAng="-5400000"/>
                <a:lnTo>
                  <a:pt x="10800" y="749172"/>
                </a:lnTo>
                <a:arcTo wR="10800" hR="10800" stAng="5400000" swAng="-5400000"/>
                <a:lnTo>
                  <a:pt x="21600" y="10800"/>
                </a:lnTo>
                <a:arcTo wR="10800" hR="10800" stAng="0" swAng="-5400000"/>
                <a:close/>
              </a:path>
            </a:pathLst>
          </a:custGeom>
          <a:noFill/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22"/>
          <p:cNvSpPr/>
          <p:nvPr/>
        </p:nvSpPr>
        <p:spPr>
          <a:xfrm>
            <a:off x="569160" y="144792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AutoShape 23"/>
          <p:cNvSpPr/>
          <p:nvPr/>
        </p:nvSpPr>
        <p:spPr>
          <a:xfrm>
            <a:off x="1681200" y="1566720"/>
            <a:ext cx="52200" cy="1411560"/>
          </a:xfrm>
          <a:custGeom>
            <a:avLst/>
            <a:gdLst>
              <a:gd name="textAreaLeft" fmla="*/ 6840 w 52200"/>
              <a:gd name="textAreaRight" fmla="*/ 45360 w 52200"/>
              <a:gd name="textAreaTop" fmla="*/ 6840 h 1411560"/>
              <a:gd name="textAreaBottom" fmla="*/ 1404720 h 1411560"/>
            </a:gdLst>
            <a:ahLst/>
            <a:rect l="textAreaLeft" t="textAreaTop" r="textAreaRight" b="textAreaBottom"/>
            <a:pathLst>
              <a:path w="21600" h="580241">
                <a:moveTo>
                  <a:pt x="9900" y="0"/>
                </a:moveTo>
                <a:arcTo wR="9900" hR="9900" stAng="16200000" swAng="-5400000"/>
                <a:lnTo>
                  <a:pt x="0" y="570341"/>
                </a:lnTo>
                <a:arcTo wR="9900" hR="9900" stAng="10800000" swAng="-5400000"/>
                <a:lnTo>
                  <a:pt x="11700" y="580241"/>
                </a:lnTo>
                <a:arcTo wR="9900" hR="9900" stAng="5400000" swAng="-5400000"/>
                <a:lnTo>
                  <a:pt x="21600" y="9900"/>
                </a:lnTo>
                <a:arcTo wR="9900" hR="9900" stAng="0" swAng="-5400000"/>
                <a:close/>
              </a:path>
            </a:pathLst>
          </a:cu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24"/>
          <p:cNvSpPr/>
          <p:nvPr/>
        </p:nvSpPr>
        <p:spPr>
          <a:xfrm>
            <a:off x="1675800" y="144792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AutoShape 25"/>
          <p:cNvSpPr/>
          <p:nvPr/>
        </p:nvSpPr>
        <p:spPr>
          <a:xfrm>
            <a:off x="1676520" y="3191040"/>
            <a:ext cx="55440" cy="823680"/>
          </a:xfrm>
          <a:custGeom>
            <a:avLst/>
            <a:gdLst>
              <a:gd name="textAreaLeft" fmla="*/ 6840 w 55440"/>
              <a:gd name="textAreaRight" fmla="*/ 48600 w 55440"/>
              <a:gd name="textAreaTop" fmla="*/ 6840 h 823680"/>
              <a:gd name="textAreaBottom" fmla="*/ 816840 h 823680"/>
            </a:gdLst>
            <a:ahLst/>
            <a:rect l="textAreaLeft" t="textAreaTop" r="textAreaRight" b="textAreaBottom"/>
            <a:pathLst>
              <a:path w="21600" h="318983">
                <a:moveTo>
                  <a:pt x="9138" y="0"/>
                </a:moveTo>
                <a:arcTo wR="9138" hR="9138" stAng="16200000" swAng="-5400000"/>
                <a:lnTo>
                  <a:pt x="0" y="309845"/>
                </a:lnTo>
                <a:arcTo wR="9138" hR="9138" stAng="10800000" swAng="-5400000"/>
                <a:lnTo>
                  <a:pt x="12462" y="318983"/>
                </a:lnTo>
                <a:arcTo wR="9138" hR="9138" stAng="5400000" swAng="-5400000"/>
                <a:lnTo>
                  <a:pt x="21600" y="9138"/>
                </a:lnTo>
                <a:arcTo wR="9138" hR="9138" stAng="0" swAng="-5400000"/>
                <a:close/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26"/>
          <p:cNvSpPr/>
          <p:nvPr/>
        </p:nvSpPr>
        <p:spPr>
          <a:xfrm>
            <a:off x="1675800" y="307008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AutoShape 27"/>
          <p:cNvSpPr/>
          <p:nvPr/>
        </p:nvSpPr>
        <p:spPr>
          <a:xfrm>
            <a:off x="2779560" y="1565280"/>
            <a:ext cx="51120" cy="2239920"/>
          </a:xfrm>
          <a:custGeom>
            <a:avLst/>
            <a:gdLst>
              <a:gd name="textAreaLeft" fmla="*/ 6120 w 51120"/>
              <a:gd name="textAreaRight" fmla="*/ 45000 w 51120"/>
              <a:gd name="textAreaTop" fmla="*/ 6120 h 2239920"/>
              <a:gd name="textAreaBottom" fmla="*/ 2233800 h 2239920"/>
            </a:gdLst>
            <a:ahLst/>
            <a:rect l="textAreaLeft" t="textAreaTop" r="textAreaRight" b="textAreaBottom"/>
            <a:pathLst>
              <a:path w="21600" h="939978">
                <a:moveTo>
                  <a:pt x="9138" y="0"/>
                </a:moveTo>
                <a:arcTo wR="9138" hR="9138" stAng="16200000" swAng="-5400000"/>
                <a:lnTo>
                  <a:pt x="0" y="930840"/>
                </a:lnTo>
                <a:arcTo wR="9138" hR="9138" stAng="10800000" swAng="-5400000"/>
                <a:lnTo>
                  <a:pt x="12462" y="939978"/>
                </a:lnTo>
                <a:arcTo wR="9138" hR="9138" stAng="5400000" swAng="-5400000"/>
                <a:lnTo>
                  <a:pt x="21600" y="9138"/>
                </a:lnTo>
                <a:arcTo wR="9138" hR="9138" stAng="0" swAng="-5400000"/>
                <a:close/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28"/>
          <p:cNvSpPr/>
          <p:nvPr/>
        </p:nvSpPr>
        <p:spPr>
          <a:xfrm>
            <a:off x="2775960" y="144792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AutoShape 29"/>
          <p:cNvSpPr/>
          <p:nvPr/>
        </p:nvSpPr>
        <p:spPr>
          <a:xfrm>
            <a:off x="6927840" y="1596960"/>
            <a:ext cx="49320" cy="1479600"/>
          </a:xfrm>
          <a:custGeom>
            <a:avLst/>
            <a:gdLst>
              <a:gd name="textAreaLeft" fmla="*/ 6120 w 49320"/>
              <a:gd name="textAreaRight" fmla="*/ 43200 w 49320"/>
              <a:gd name="textAreaTop" fmla="*/ 6120 h 1479600"/>
              <a:gd name="textAreaBottom" fmla="*/ 1473480 h 1479600"/>
            </a:gdLst>
            <a:ahLst/>
            <a:rect l="textAreaLeft" t="textAreaTop" r="textAreaRight" b="textAreaBottom"/>
            <a:pathLst>
              <a:path w="21600" h="643461">
                <a:moveTo>
                  <a:pt x="9138" y="0"/>
                </a:moveTo>
                <a:arcTo wR="9138" hR="9138" stAng="16200000" swAng="-5400000"/>
                <a:lnTo>
                  <a:pt x="0" y="634323"/>
                </a:lnTo>
                <a:arcTo wR="9138" hR="9138" stAng="10800000" swAng="-5400000"/>
                <a:lnTo>
                  <a:pt x="12462" y="643461"/>
                </a:lnTo>
                <a:arcTo wR="9138" hR="9138" stAng="5400000" swAng="-5400000"/>
                <a:lnTo>
                  <a:pt x="21600" y="9138"/>
                </a:lnTo>
                <a:arcTo wR="9138" hR="9138" stAng="0" swAng="-5400000"/>
                <a:close/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30"/>
          <p:cNvSpPr/>
          <p:nvPr/>
        </p:nvSpPr>
        <p:spPr>
          <a:xfrm>
            <a:off x="6894000" y="144792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9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AutoShape 31"/>
          <p:cNvSpPr/>
          <p:nvPr/>
        </p:nvSpPr>
        <p:spPr>
          <a:xfrm>
            <a:off x="3914640" y="1574640"/>
            <a:ext cx="49320" cy="971640"/>
          </a:xfrm>
          <a:custGeom>
            <a:avLst/>
            <a:gdLst>
              <a:gd name="textAreaLeft" fmla="*/ 7200 w 49320"/>
              <a:gd name="textAreaRight" fmla="*/ 42120 w 49320"/>
              <a:gd name="textAreaTop" fmla="*/ 7200 h 971640"/>
              <a:gd name="textAreaBottom" fmla="*/ 964440 h 971640"/>
            </a:gdLst>
            <a:ahLst/>
            <a:rect l="textAreaLeft" t="textAreaTop" r="textAreaRight" b="textAreaBottom"/>
            <a:pathLst>
              <a:path w="21600" h="422609">
                <a:moveTo>
                  <a:pt x="10800" y="0"/>
                </a:moveTo>
                <a:arcTo wR="10800" hR="10800" stAng="16200000" swAng="-5400000"/>
                <a:lnTo>
                  <a:pt x="0" y="411809"/>
                </a:lnTo>
                <a:arcTo wR="10800" hR="10800" stAng="10800000" swAng="-5400000"/>
                <a:lnTo>
                  <a:pt x="10800" y="422609"/>
                </a:lnTo>
                <a:arcTo wR="10800" hR="10800" stAng="5400000" swAng="-5400000"/>
                <a:lnTo>
                  <a:pt x="21600" y="10800"/>
                </a:lnTo>
                <a:arcTo wR="10800" hR="10800" stAng="0" swAng="-5400000"/>
                <a:close/>
              </a:path>
            </a:pathLst>
          </a:custGeom>
          <a:noFill/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ectangle 32"/>
          <p:cNvSpPr/>
          <p:nvPr/>
        </p:nvSpPr>
        <p:spPr>
          <a:xfrm>
            <a:off x="3891960" y="144792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AutoShape 33"/>
          <p:cNvSpPr/>
          <p:nvPr/>
        </p:nvSpPr>
        <p:spPr>
          <a:xfrm>
            <a:off x="3917880" y="2798640"/>
            <a:ext cx="52560" cy="1230480"/>
          </a:xfrm>
          <a:custGeom>
            <a:avLst/>
            <a:gdLst>
              <a:gd name="textAreaLeft" fmla="*/ 6840 w 52560"/>
              <a:gd name="textAreaRight" fmla="*/ 45720 w 52560"/>
              <a:gd name="textAreaTop" fmla="*/ 6840 h 1230480"/>
              <a:gd name="textAreaBottom" fmla="*/ 1223640 h 1230480"/>
            </a:gdLst>
            <a:ahLst/>
            <a:rect l="textAreaLeft" t="textAreaTop" r="textAreaRight" b="textAreaBottom"/>
            <a:pathLst>
              <a:path w="21600" h="502384">
                <a:moveTo>
                  <a:pt x="9900" y="0"/>
                </a:moveTo>
                <a:arcTo wR="9900" hR="9900" stAng="16200000" swAng="-5400000"/>
                <a:lnTo>
                  <a:pt x="0" y="492484"/>
                </a:lnTo>
                <a:arcTo wR="9900" hR="9900" stAng="10800000" swAng="-5400000"/>
                <a:lnTo>
                  <a:pt x="11700" y="502384"/>
                </a:lnTo>
                <a:arcTo wR="9900" hR="9900" stAng="5400000" swAng="-5400000"/>
                <a:lnTo>
                  <a:pt x="21600" y="9900"/>
                </a:lnTo>
                <a:arcTo wR="9900" hR="9900" stAng="0" swAng="-5400000"/>
                <a:close/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34"/>
          <p:cNvSpPr/>
          <p:nvPr/>
        </p:nvSpPr>
        <p:spPr>
          <a:xfrm>
            <a:off x="3901320" y="264780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AutoShape 35"/>
          <p:cNvSpPr/>
          <p:nvPr/>
        </p:nvSpPr>
        <p:spPr>
          <a:xfrm>
            <a:off x="5894280" y="1582560"/>
            <a:ext cx="60480" cy="1667160"/>
          </a:xfrm>
          <a:custGeom>
            <a:avLst/>
            <a:gdLst>
              <a:gd name="textAreaLeft" fmla="*/ 7200 w 60480"/>
              <a:gd name="textAreaRight" fmla="*/ 53280 w 60480"/>
              <a:gd name="textAreaTop" fmla="*/ 7200 h 1667160"/>
              <a:gd name="textAreaBottom" fmla="*/ 1659960 h 1667160"/>
            </a:gdLst>
            <a:ahLst/>
            <a:rect l="textAreaLeft" t="textAreaTop" r="textAreaRight" b="textAreaBottom"/>
            <a:pathLst>
              <a:path w="21600" h="592019">
                <a:moveTo>
                  <a:pt x="9138" y="0"/>
                </a:moveTo>
                <a:arcTo wR="9138" hR="9138" stAng="16200000" swAng="-5400000"/>
                <a:lnTo>
                  <a:pt x="0" y="582881"/>
                </a:lnTo>
                <a:arcTo wR="9138" hR="9138" stAng="10800000" swAng="-5400000"/>
                <a:lnTo>
                  <a:pt x="12462" y="592019"/>
                </a:lnTo>
                <a:arcTo wR="9138" hR="9138" stAng="5400000" swAng="-5400000"/>
                <a:lnTo>
                  <a:pt x="21600" y="9138"/>
                </a:lnTo>
                <a:arcTo wR="9138" hR="9138" stAng="0" swAng="-5400000"/>
                <a:close/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36"/>
          <p:cNvSpPr/>
          <p:nvPr/>
        </p:nvSpPr>
        <p:spPr>
          <a:xfrm>
            <a:off x="5874840" y="144792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AutoShape 37"/>
          <p:cNvSpPr/>
          <p:nvPr/>
        </p:nvSpPr>
        <p:spPr>
          <a:xfrm>
            <a:off x="4913280" y="1596960"/>
            <a:ext cx="57240" cy="1633680"/>
          </a:xfrm>
          <a:custGeom>
            <a:avLst/>
            <a:gdLst>
              <a:gd name="textAreaLeft" fmla="*/ 6840 w 57240"/>
              <a:gd name="textAreaRight" fmla="*/ 50400 w 57240"/>
              <a:gd name="textAreaTop" fmla="*/ 6840 h 1633680"/>
              <a:gd name="textAreaBottom" fmla="*/ 1626840 h 1633680"/>
            </a:gdLst>
            <a:ahLst/>
            <a:rect l="textAreaLeft" t="textAreaTop" r="textAreaRight" b="textAreaBottom"/>
            <a:pathLst>
              <a:path w="21600" h="612765">
                <a:moveTo>
                  <a:pt x="9138" y="0"/>
                </a:moveTo>
                <a:arcTo wR="9138" hR="9138" stAng="16200000" swAng="-5400000"/>
                <a:lnTo>
                  <a:pt x="0" y="603627"/>
                </a:lnTo>
                <a:arcTo wR="9138" hR="9138" stAng="10800000" swAng="-5400000"/>
                <a:lnTo>
                  <a:pt x="12462" y="612765"/>
                </a:lnTo>
                <a:arcTo wR="9138" hR="9138" stAng="5400000" swAng="-5400000"/>
                <a:lnTo>
                  <a:pt x="21600" y="9138"/>
                </a:lnTo>
                <a:arcTo wR="9138" hR="9138" stAng="0" swAng="-5400000"/>
                <a:close/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38"/>
          <p:cNvSpPr/>
          <p:nvPr/>
        </p:nvSpPr>
        <p:spPr>
          <a:xfrm>
            <a:off x="4888800" y="144792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AutoShape 39"/>
          <p:cNvSpPr/>
          <p:nvPr/>
        </p:nvSpPr>
        <p:spPr>
          <a:xfrm>
            <a:off x="7915320" y="1563840"/>
            <a:ext cx="55440" cy="1846080"/>
          </a:xfrm>
          <a:custGeom>
            <a:avLst/>
            <a:gdLst>
              <a:gd name="textAreaLeft" fmla="*/ 7200 w 55440"/>
              <a:gd name="textAreaRight" fmla="*/ 48240 w 55440"/>
              <a:gd name="textAreaTop" fmla="*/ 7200 h 1846080"/>
              <a:gd name="textAreaBottom" fmla="*/ 1838880 h 1846080"/>
            </a:gdLst>
            <a:ahLst/>
            <a:rect l="textAreaLeft" t="textAreaTop" r="textAreaRight" b="textAreaBottom"/>
            <a:pathLst>
              <a:path w="21600" h="714751">
                <a:moveTo>
                  <a:pt x="9900" y="0"/>
                </a:moveTo>
                <a:arcTo wR="9900" hR="9900" stAng="16200000" swAng="-5400000"/>
                <a:lnTo>
                  <a:pt x="0" y="704851"/>
                </a:lnTo>
                <a:arcTo wR="9900" hR="9900" stAng="10800000" swAng="-5400000"/>
                <a:lnTo>
                  <a:pt x="11700" y="714751"/>
                </a:lnTo>
                <a:arcTo wR="9900" hR="9900" stAng="5400000" swAng="-5400000"/>
                <a:lnTo>
                  <a:pt x="21600" y="9900"/>
                </a:lnTo>
                <a:arcTo wR="9900" hR="9900" stAng="0" swAng="-5400000"/>
                <a:close/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ectangle 40"/>
          <p:cNvSpPr/>
          <p:nvPr/>
        </p:nvSpPr>
        <p:spPr>
          <a:xfrm>
            <a:off x="7842960" y="1447920"/>
            <a:ext cx="128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49"/>
          <p:cNvSpPr/>
          <p:nvPr/>
        </p:nvSpPr>
        <p:spPr>
          <a:xfrm>
            <a:off x="3756960" y="4343400"/>
            <a:ext cx="128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1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79"/>
          <p:cNvSpPr/>
          <p:nvPr/>
        </p:nvSpPr>
        <p:spPr>
          <a:xfrm>
            <a:off x="554040" y="3067200"/>
            <a:ext cx="85680" cy="144360"/>
          </a:xfrm>
          <a:prstGeom prst="rect">
            <a:avLst/>
          </a:prstGeom>
          <a:blipFill rotWithShape="0">
            <a:blip r:embed="rId1"/>
            <a:srcRect/>
            <a:tile tx="0" ty="0" sx="100000" sy="100000" algn="ctr"/>
          </a:blip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Rectangle 82"/>
          <p:cNvSpPr/>
          <p:nvPr/>
        </p:nvSpPr>
        <p:spPr>
          <a:xfrm>
            <a:off x="1660680" y="3840120"/>
            <a:ext cx="85680" cy="144360"/>
          </a:xfrm>
          <a:prstGeom prst="rect">
            <a:avLst/>
          </a:prstGeom>
          <a:blipFill rotWithShape="0">
            <a:blip r:embed="rId2"/>
            <a:srcRect/>
            <a:tile tx="0" ty="0" sx="100000" sy="100000" algn="ctr"/>
          </a:blip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Rectangle 83"/>
          <p:cNvSpPr/>
          <p:nvPr/>
        </p:nvSpPr>
        <p:spPr>
          <a:xfrm>
            <a:off x="1660680" y="3679920"/>
            <a:ext cx="85680" cy="144360"/>
          </a:xfrm>
          <a:prstGeom prst="rect">
            <a:avLst/>
          </a:prstGeom>
          <a:blipFill rotWithShape="0">
            <a:blip r:embed="rId3"/>
            <a:srcRect/>
            <a:tile tx="0" ty="0" sx="100000" sy="100000" algn="ctr"/>
          </a:blip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Rectangle 84"/>
          <p:cNvSpPr/>
          <p:nvPr/>
        </p:nvSpPr>
        <p:spPr>
          <a:xfrm>
            <a:off x="3895560" y="2332080"/>
            <a:ext cx="86040" cy="144360"/>
          </a:xfrm>
          <a:prstGeom prst="rect">
            <a:avLst/>
          </a:prstGeom>
          <a:blipFill rotWithShape="0">
            <a:blip r:embed="rId4"/>
            <a:srcRect/>
            <a:tile tx="0" ty="0" sx="100000" sy="100000" algn="ctr"/>
          </a:blip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Rectangle 85"/>
          <p:cNvSpPr/>
          <p:nvPr/>
        </p:nvSpPr>
        <p:spPr>
          <a:xfrm>
            <a:off x="5033880" y="5837400"/>
            <a:ext cx="85680" cy="144360"/>
          </a:xfrm>
          <a:prstGeom prst="rect">
            <a:avLst/>
          </a:prstGeom>
          <a:blipFill rotWithShape="0">
            <a:blip r:embed="rId5"/>
            <a:srcRect/>
            <a:tile tx="0" ty="0" sx="100000" sy="100000" algn="ctr"/>
          </a:blip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Rectangle 86"/>
          <p:cNvSpPr/>
          <p:nvPr/>
        </p:nvSpPr>
        <p:spPr>
          <a:xfrm>
            <a:off x="1663560" y="1998720"/>
            <a:ext cx="86040" cy="144360"/>
          </a:xfrm>
          <a:prstGeom prst="rect">
            <a:avLst/>
          </a:prstGeom>
          <a:blipFill rotWithShape="0">
            <a:blip r:embed="rId6"/>
            <a:srcRect/>
            <a:tile tx="0" ty="0" sx="100000" sy="100000" algn="ctr"/>
          </a:blip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Rectangle 87"/>
          <p:cNvSpPr/>
          <p:nvPr/>
        </p:nvSpPr>
        <p:spPr>
          <a:xfrm>
            <a:off x="3897360" y="3354480"/>
            <a:ext cx="85680" cy="144360"/>
          </a:xfrm>
          <a:prstGeom prst="rect">
            <a:avLst/>
          </a:prstGeom>
          <a:blipFill rotWithShape="0">
            <a:blip r:embed="rId7"/>
            <a:srcRect/>
            <a:tile tx="0" ty="0" sx="100000" sy="100000" algn="ctr"/>
          </a:blip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Rectangle 88"/>
          <p:cNvSpPr/>
          <p:nvPr/>
        </p:nvSpPr>
        <p:spPr>
          <a:xfrm>
            <a:off x="555480" y="2890800"/>
            <a:ext cx="86040" cy="144360"/>
          </a:xfrm>
          <a:prstGeom prst="rect">
            <a:avLst/>
          </a:prstGeom>
          <a:blipFill rotWithShape="0">
            <a:blip r:embed="rId8"/>
            <a:srcRect/>
            <a:tile tx="0" ty="0" sx="100000" sy="100000" algn="ctr"/>
          </a:blip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Rectangle 89"/>
          <p:cNvSpPr/>
          <p:nvPr/>
        </p:nvSpPr>
        <p:spPr>
          <a:xfrm>
            <a:off x="5881680" y="1633680"/>
            <a:ext cx="85680" cy="144360"/>
          </a:xfrm>
          <a:prstGeom prst="rect">
            <a:avLst/>
          </a:prstGeom>
          <a:blipFill rotWithShape="0">
            <a:blip r:embed="rId9"/>
            <a:srcRect/>
            <a:tile tx="0" ty="0" sx="100000" sy="100000" algn="ctr"/>
          </a:blip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Rectangle 90"/>
          <p:cNvSpPr/>
          <p:nvPr/>
        </p:nvSpPr>
        <p:spPr>
          <a:xfrm>
            <a:off x="5881680" y="1792440"/>
            <a:ext cx="85680" cy="144360"/>
          </a:xfrm>
          <a:prstGeom prst="rect">
            <a:avLst/>
          </a:prstGeom>
          <a:blipFill rotWithShape="0">
            <a:blip r:embed="rId10"/>
            <a:srcRect/>
            <a:tile tx="0" ty="0" sx="100000" sy="100000" algn="ctr"/>
          </a:blip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Rectangle 91"/>
          <p:cNvSpPr/>
          <p:nvPr/>
        </p:nvSpPr>
        <p:spPr>
          <a:xfrm>
            <a:off x="1666800" y="2787480"/>
            <a:ext cx="85680" cy="144720"/>
          </a:xfrm>
          <a:prstGeom prst="rect">
            <a:avLst/>
          </a:prstGeom>
          <a:blipFill rotWithShape="0">
            <a:blip r:embed="rId11"/>
            <a:srcRect/>
            <a:tile tx="0" ty="0" sx="100000" sy="100000" algn="ctr"/>
          </a:blip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Rectangle 92"/>
          <p:cNvSpPr/>
          <p:nvPr/>
        </p:nvSpPr>
        <p:spPr>
          <a:xfrm>
            <a:off x="574560" y="5675400"/>
            <a:ext cx="85680" cy="144360"/>
          </a:xfrm>
          <a:prstGeom prst="rect">
            <a:avLst/>
          </a:prstGeom>
          <a:blipFill rotWithShape="0">
            <a:blip r:embed="rId12"/>
            <a:srcRect/>
            <a:tile tx="0" ty="0" sx="100000" sy="100000" algn="ctr"/>
          </a:blip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Rectangle 93"/>
          <p:cNvSpPr/>
          <p:nvPr/>
        </p:nvSpPr>
        <p:spPr>
          <a:xfrm>
            <a:off x="3898800" y="1609560"/>
            <a:ext cx="85680" cy="144720"/>
          </a:xfrm>
          <a:prstGeom prst="rect">
            <a:avLst/>
          </a:prstGeom>
          <a:blipFill rotWithShape="0">
            <a:blip r:embed="rId13"/>
            <a:srcRect/>
            <a:tile tx="0" ty="0" sx="100000" sy="100000" algn="ctr"/>
          </a:blip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Rectangle 94"/>
          <p:cNvSpPr/>
          <p:nvPr/>
        </p:nvSpPr>
        <p:spPr>
          <a:xfrm>
            <a:off x="6908760" y="2741760"/>
            <a:ext cx="85680" cy="144360"/>
          </a:xfrm>
          <a:prstGeom prst="rect">
            <a:avLst/>
          </a:prstGeom>
          <a:blipFill rotWithShape="0">
            <a:blip r:embed="rId14"/>
            <a:srcRect/>
            <a:tile tx="0" ty="0" sx="100000" sy="100000" algn="ctr"/>
          </a:blip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Rectangle 95"/>
          <p:cNvSpPr/>
          <p:nvPr/>
        </p:nvSpPr>
        <p:spPr>
          <a:xfrm>
            <a:off x="7897680" y="2487600"/>
            <a:ext cx="85680" cy="144360"/>
          </a:xfrm>
          <a:prstGeom prst="rect">
            <a:avLst/>
          </a:prstGeom>
          <a:blipFill rotWithShape="0">
            <a:blip r:embed="rId15"/>
            <a:srcRect/>
            <a:tile tx="0" ty="0" sx="100000" sy="100000" algn="ctr"/>
          </a:blip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Rectangle 96"/>
          <p:cNvSpPr/>
          <p:nvPr/>
        </p:nvSpPr>
        <p:spPr>
          <a:xfrm>
            <a:off x="5842080" y="4554360"/>
            <a:ext cx="85680" cy="144720"/>
          </a:xfrm>
          <a:prstGeom prst="rect">
            <a:avLst/>
          </a:prstGeom>
          <a:blipFill rotWithShape="0">
            <a:blip r:embed="rId16"/>
            <a:srcRect/>
            <a:tile tx="0" ty="0" sx="100000" sy="100000" algn="ctr"/>
          </a:blip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 Box 98"/>
          <p:cNvSpPr/>
          <p:nvPr/>
        </p:nvSpPr>
        <p:spPr>
          <a:xfrm>
            <a:off x="564840" y="3068640"/>
            <a:ext cx="111024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500" spc="-1" strike="noStrike">
                <a:solidFill>
                  <a:srgbClr val="000000"/>
                </a:solidFill>
                <a:latin typeface="Arial"/>
              </a:rPr>
              <a:t>RT- Rice tungro bacilliform virus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posit: 120,261,152..120,261,368 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 Box 100"/>
          <p:cNvSpPr/>
          <p:nvPr/>
        </p:nvSpPr>
        <p:spPr>
          <a:xfrm>
            <a:off x="555480" y="2846520"/>
            <a:ext cx="111024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500" spc="-1" strike="noStrike">
                <a:solidFill>
                  <a:srgbClr val="000000"/>
                </a:solidFill>
                <a:latin typeface="Arial"/>
              </a:rPr>
              <a:t>RT- </a:t>
            </a:r>
            <a:r>
              <a:rPr b="0" i="1" lang="en-GB" sz="500" spc="-1" strike="noStrike">
                <a:solidFill>
                  <a:srgbClr val="000000"/>
                </a:solidFill>
                <a:latin typeface="Arial"/>
              </a:rPr>
              <a:t>Lamium leaf dist. ass. virus</a:t>
            </a: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posit: 117,898,214..117,899,037 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 Box 102"/>
          <p:cNvSpPr/>
          <p:nvPr/>
        </p:nvSpPr>
        <p:spPr>
          <a:xfrm>
            <a:off x="608040" y="5627520"/>
            <a:ext cx="108288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500" spc="-1" strike="noStrike">
                <a:solidFill>
                  <a:srgbClr val="000000"/>
                </a:solidFill>
                <a:latin typeface="Arial"/>
              </a:rPr>
              <a:t>RT- Carnation etched ring virus</a:t>
            </a: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posit: 11,149,476..11,150,121 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 Box 103"/>
          <p:cNvSpPr/>
          <p:nvPr/>
        </p:nvSpPr>
        <p:spPr>
          <a:xfrm>
            <a:off x="1666080" y="3645000"/>
            <a:ext cx="108612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500" spc="-1" strike="noStrike">
                <a:solidFill>
                  <a:srgbClr val="000000"/>
                </a:solidFill>
                <a:latin typeface="Arial"/>
              </a:rPr>
              <a:t>RT- Rice tungro bacilliform virus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posit: 8,822,689..8,823,246 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 Box 105"/>
          <p:cNvSpPr/>
          <p:nvPr/>
        </p:nvSpPr>
        <p:spPr>
          <a:xfrm>
            <a:off x="1666080" y="3832200"/>
            <a:ext cx="108612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500" spc="-1" strike="noStrike">
                <a:solidFill>
                  <a:srgbClr val="000000"/>
                </a:solidFill>
                <a:latin typeface="Arial"/>
              </a:rPr>
              <a:t>RT- Rice tungro bacilliform virus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posit: 9,805,215..9,805,809 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 Box 106"/>
          <p:cNvSpPr/>
          <p:nvPr/>
        </p:nvSpPr>
        <p:spPr>
          <a:xfrm>
            <a:off x="1690560" y="1960560"/>
            <a:ext cx="100836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500" spc="-1" strike="noStrike">
                <a:solidFill>
                  <a:srgbClr val="000000"/>
                </a:solidFill>
                <a:latin typeface="Arial"/>
              </a:rPr>
              <a:t>RT- Cauliflower mosaic virus</a:t>
            </a: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posit: 8,872,185..8,872,457 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 Box 109"/>
          <p:cNvSpPr/>
          <p:nvPr/>
        </p:nvSpPr>
        <p:spPr>
          <a:xfrm>
            <a:off x="1689120" y="2752560"/>
            <a:ext cx="108288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500" spc="-1" strike="noStrike">
                <a:solidFill>
                  <a:srgbClr val="000000"/>
                </a:solidFill>
                <a:latin typeface="Arial"/>
              </a:rPr>
              <a:t>RT- Carnation etched ring virus</a:t>
            </a: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posit: 16,370,519..16,370,830 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 Box 110"/>
          <p:cNvSpPr/>
          <p:nvPr/>
        </p:nvSpPr>
        <p:spPr>
          <a:xfrm>
            <a:off x="3904200" y="2276640"/>
            <a:ext cx="108612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500" spc="-1" strike="noStrike">
                <a:solidFill>
                  <a:srgbClr val="000000"/>
                </a:solidFill>
                <a:latin typeface="Arial"/>
              </a:rPr>
              <a:t>RT- Rice tungro bacilliform virus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posit: 18,556,193..18,556,564 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 Box 111"/>
          <p:cNvSpPr/>
          <p:nvPr/>
        </p:nvSpPr>
        <p:spPr>
          <a:xfrm>
            <a:off x="5878440" y="1770120"/>
            <a:ext cx="109368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500" spc="-1" strike="noStrike">
                <a:solidFill>
                  <a:srgbClr val="000000"/>
                </a:solidFill>
                <a:latin typeface="Arial"/>
              </a:rPr>
              <a:t>RT- </a:t>
            </a:r>
            <a:r>
              <a:rPr b="0" i="1" lang="en-GB" sz="500" spc="-1" strike="noStrike">
                <a:solidFill>
                  <a:srgbClr val="000000"/>
                </a:solidFill>
                <a:latin typeface="Arial"/>
              </a:rPr>
              <a:t>Lamium leaf dist. ass. virus</a:t>
            </a: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posit: 6,149,976..6,150,701 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 Box 112"/>
          <p:cNvSpPr/>
          <p:nvPr/>
        </p:nvSpPr>
        <p:spPr>
          <a:xfrm>
            <a:off x="3908520" y="1557360"/>
            <a:ext cx="108288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500" spc="-1" strike="noStrike">
                <a:solidFill>
                  <a:srgbClr val="000000"/>
                </a:solidFill>
                <a:latin typeface="Arial"/>
              </a:rPr>
              <a:t>RT- Carnation etched ring virus</a:t>
            </a: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posit: 2,240,705..2,241,424 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 Box 113"/>
          <p:cNvSpPr/>
          <p:nvPr/>
        </p:nvSpPr>
        <p:spPr>
          <a:xfrm>
            <a:off x="3921120" y="3328920"/>
            <a:ext cx="116064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500" spc="-1" strike="noStrike">
                <a:solidFill>
                  <a:srgbClr val="000000"/>
                </a:solidFill>
                <a:latin typeface="Arial"/>
              </a:rPr>
              <a:t>RT- Strawberry vein banding virus</a:t>
            </a: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posit: 12,644,211..12,644,470 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Text Box 114"/>
          <p:cNvSpPr/>
          <p:nvPr/>
        </p:nvSpPr>
        <p:spPr>
          <a:xfrm>
            <a:off x="5870520" y="1600200"/>
            <a:ext cx="116064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500" spc="-1" strike="noStrike">
                <a:solidFill>
                  <a:srgbClr val="000000"/>
                </a:solidFill>
                <a:latin typeface="Arial"/>
              </a:rPr>
              <a:t>RT- Strawberry vein banding virus</a:t>
            </a: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posit: 4,148,212..4,148,460 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 Box 115"/>
          <p:cNvSpPr/>
          <p:nvPr/>
        </p:nvSpPr>
        <p:spPr>
          <a:xfrm>
            <a:off x="5864040" y="4508640"/>
            <a:ext cx="108288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500" spc="-1" strike="noStrike">
                <a:solidFill>
                  <a:srgbClr val="000000"/>
                </a:solidFill>
                <a:latin typeface="Arial"/>
              </a:rPr>
              <a:t>RT- Carnation etched ring virus</a:t>
            </a: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posit: 2,076,764..2,077,483 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Text Box 116"/>
          <p:cNvSpPr/>
          <p:nvPr/>
        </p:nvSpPr>
        <p:spPr>
          <a:xfrm>
            <a:off x="5050440" y="5780160"/>
            <a:ext cx="108612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500" spc="-1" strike="noStrike">
                <a:solidFill>
                  <a:srgbClr val="000000"/>
                </a:solidFill>
                <a:latin typeface="Arial"/>
              </a:rPr>
              <a:t>RT- Rice tungro bacilliform virus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posit: 4,304,137..4,304,751 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ext Box 117"/>
          <p:cNvSpPr/>
          <p:nvPr/>
        </p:nvSpPr>
        <p:spPr>
          <a:xfrm>
            <a:off x="6904080" y="2685960"/>
            <a:ext cx="108288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500" spc="-1" strike="noStrike">
                <a:solidFill>
                  <a:srgbClr val="000000"/>
                </a:solidFill>
                <a:latin typeface="Arial"/>
              </a:rPr>
              <a:t>RT- Carnation etched ring virus</a:t>
            </a: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posit: 13,714,314..13,715,033 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Text Box 118"/>
          <p:cNvSpPr/>
          <p:nvPr/>
        </p:nvSpPr>
        <p:spPr>
          <a:xfrm>
            <a:off x="7893000" y="2430360"/>
            <a:ext cx="108288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500" spc="-1" strike="noStrike">
                <a:solidFill>
                  <a:srgbClr val="000000"/>
                </a:solidFill>
                <a:latin typeface="Arial"/>
              </a:rPr>
              <a:t>RT- Carnation etched ring virus</a:t>
            </a: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500" spc="-1" strike="noStrike">
                <a:solidFill>
                  <a:srgbClr val="000000"/>
                </a:solidFill>
                <a:latin typeface="Arial"/>
              </a:rPr>
              <a:t>posit: 4,303,075..4,303,794 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 Box 119"/>
          <p:cNvSpPr/>
          <p:nvPr/>
        </p:nvSpPr>
        <p:spPr>
          <a:xfrm>
            <a:off x="376200" y="209520"/>
            <a:ext cx="85168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</a:rPr>
              <a:t>Supplemental Figure S1.</a:t>
            </a: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Positions of the pararetrovirus-related inserts in the grapevine chromosomes</a:t>
            </a:r>
            <a:r>
              <a:rPr b="0" i="1" lang="fr-FR" sz="1200" spc="-1" strike="noStrike">
                <a:solidFill>
                  <a:srgbClr val="000000"/>
                </a:solidFill>
                <a:latin typeface="Arial"/>
              </a:rPr>
              <a:t>. </a:t>
            </a: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The insert sizes are not to scale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6-02T20:08:20Z</dcterms:created>
  <dc:creator>Frederique PELSY</dc:creator>
  <dc:description/>
  <dc:language>en-US</dc:language>
  <cp:lastModifiedBy>PEPS AGRO BIOPOLE</cp:lastModifiedBy>
  <dcterms:modified xsi:type="dcterms:W3CDTF">2009-06-05T20:31:20Z</dcterms:modified>
  <cp:revision>8</cp:revision>
  <dc:subject/>
  <dc:title>Carte vierge vigne</dc:title>
</cp:coreProperties>
</file>